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0" r:id="rId2"/>
    <p:sldId id="278" r:id="rId3"/>
  </p:sldIdLst>
  <p:sldSz cx="6858000" cy="121920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51" d="100"/>
          <a:sy n="51" d="100"/>
        </p:scale>
        <p:origin x="293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AB175-3149-4CAF-A1B0-348D98241B2B}" type="datetimeFigureOut">
              <a:rPr lang="ko-KR" altLang="en-US" smtClean="0"/>
              <a:t>2022-10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B2606-902E-4C97-9904-2A1240955B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8055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AB175-3149-4CAF-A1B0-348D98241B2B}" type="datetimeFigureOut">
              <a:rPr lang="ko-KR" altLang="en-US" smtClean="0"/>
              <a:t>2022-10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B2606-902E-4C97-9904-2A1240955B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5854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AB175-3149-4CAF-A1B0-348D98241B2B}" type="datetimeFigureOut">
              <a:rPr lang="ko-KR" altLang="en-US" smtClean="0"/>
              <a:t>2022-10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B2606-902E-4C97-9904-2A1240955B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0375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AB175-3149-4CAF-A1B0-348D98241B2B}" type="datetimeFigureOut">
              <a:rPr lang="ko-KR" altLang="en-US" smtClean="0"/>
              <a:t>2022-10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B2606-902E-4C97-9904-2A1240955B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7658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AB175-3149-4CAF-A1B0-348D98241B2B}" type="datetimeFigureOut">
              <a:rPr lang="ko-KR" altLang="en-US" smtClean="0"/>
              <a:t>2022-10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B2606-902E-4C97-9904-2A1240955B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08901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AB175-3149-4CAF-A1B0-348D98241B2B}" type="datetimeFigureOut">
              <a:rPr lang="ko-KR" altLang="en-US" smtClean="0"/>
              <a:t>2022-10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B2606-902E-4C97-9904-2A1240955B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5867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AB175-3149-4CAF-A1B0-348D98241B2B}" type="datetimeFigureOut">
              <a:rPr lang="ko-KR" altLang="en-US" smtClean="0"/>
              <a:t>2022-10-1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B2606-902E-4C97-9904-2A1240955B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11614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AB175-3149-4CAF-A1B0-348D98241B2B}" type="datetimeFigureOut">
              <a:rPr lang="ko-KR" altLang="en-US" smtClean="0"/>
              <a:t>2022-10-1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B2606-902E-4C97-9904-2A1240955B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4794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AB175-3149-4CAF-A1B0-348D98241B2B}" type="datetimeFigureOut">
              <a:rPr lang="ko-KR" altLang="en-US" smtClean="0"/>
              <a:t>2022-10-1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B2606-902E-4C97-9904-2A1240955B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3977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AB175-3149-4CAF-A1B0-348D98241B2B}" type="datetimeFigureOut">
              <a:rPr lang="ko-KR" altLang="en-US" smtClean="0"/>
              <a:t>2022-10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B2606-902E-4C97-9904-2A1240955B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343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AB175-3149-4CAF-A1B0-348D98241B2B}" type="datetimeFigureOut">
              <a:rPr lang="ko-KR" altLang="en-US" smtClean="0"/>
              <a:t>2022-10-1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1B2606-902E-4C97-9904-2A1240955B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9799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FAB175-3149-4CAF-A1B0-348D98241B2B}" type="datetimeFigureOut">
              <a:rPr lang="ko-KR" altLang="en-US" smtClean="0"/>
              <a:t>2022-10-1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1B2606-902E-4C97-9904-2A1240955B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8741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078FC0E0-37A9-4A9A-9A27-A50B3B8EC0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952" y="942285"/>
            <a:ext cx="6559865" cy="4523624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1748A983-5274-41F1-8DD7-901C542022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3951" y="5465909"/>
            <a:ext cx="6559865" cy="404199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DC66251-F04E-4F1A-813F-881D5E2DAB5E}"/>
              </a:ext>
            </a:extLst>
          </p:cNvPr>
          <p:cNvSpPr txBox="1"/>
          <p:nvPr/>
        </p:nvSpPr>
        <p:spPr>
          <a:xfrm>
            <a:off x="253951" y="480620"/>
            <a:ext cx="55476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1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List of PRC1 and PRC2 group genes in perilla from RNA sequencing </a:t>
            </a:r>
            <a:endParaRPr lang="ko-KR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63348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TextBox 63">
            <a:extLst>
              <a:ext uri="{FF2B5EF4-FFF2-40B4-BE49-F238E27FC236}">
                <a16:creationId xmlns:a16="http://schemas.microsoft.com/office/drawing/2014/main" id="{8C6976FD-93DD-4319-994E-B9D9207021B1}"/>
              </a:ext>
            </a:extLst>
          </p:cNvPr>
          <p:cNvSpPr txBox="1"/>
          <p:nvPr/>
        </p:nvSpPr>
        <p:spPr>
          <a:xfrm>
            <a:off x="471487" y="767603"/>
            <a:ext cx="37575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2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rimer sequences used in the experiments</a:t>
            </a:r>
            <a:endParaRPr lang="ko-KR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05EDC82C-DA27-46E4-904E-DF8EA17F5A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7436535"/>
              </p:ext>
            </p:extLst>
          </p:nvPr>
        </p:nvGraphicFramePr>
        <p:xfrm>
          <a:off x="471487" y="1658451"/>
          <a:ext cx="5915026" cy="133063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42698">
                  <a:extLst>
                    <a:ext uri="{9D8B030D-6E8A-4147-A177-3AD203B41FA5}">
                      <a16:colId xmlns:a16="http://schemas.microsoft.com/office/drawing/2014/main" val="1095944917"/>
                    </a:ext>
                  </a:extLst>
                </a:gridCol>
                <a:gridCol w="1721223">
                  <a:extLst>
                    <a:ext uri="{9D8B030D-6E8A-4147-A177-3AD203B41FA5}">
                      <a16:colId xmlns:a16="http://schemas.microsoft.com/office/drawing/2014/main" val="3412872679"/>
                    </a:ext>
                  </a:extLst>
                </a:gridCol>
                <a:gridCol w="3551105">
                  <a:extLst>
                    <a:ext uri="{9D8B030D-6E8A-4147-A177-3AD203B41FA5}">
                      <a16:colId xmlns:a16="http://schemas.microsoft.com/office/drawing/2014/main" val="1320102686"/>
                    </a:ext>
                  </a:extLst>
                </a:gridCol>
              </a:tblGrid>
              <a:tr h="262932">
                <a:tc>
                  <a:txBody>
                    <a:bodyPr/>
                    <a:lstStyle/>
                    <a:p>
                      <a:pPr algn="ctr" fontAlgn="base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1646" marR="51646" marT="14177" marB="14177" anchor="ctr"/>
                </a:tc>
                <a:tc gridSpan="2">
                  <a:txBody>
                    <a:bodyPr/>
                    <a:lstStyle/>
                    <a:p>
                      <a:pPr algn="ctr" fontAlgn="base" latinLnBrk="0">
                        <a:lnSpc>
                          <a:spcPct val="120000"/>
                        </a:lnSpc>
                        <a:spcAft>
                          <a:spcPts val="4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sequence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1646" marR="51646" marT="14177" marB="14177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84408915"/>
                  </a:ext>
                </a:extLst>
              </a:tr>
              <a:tr h="266926">
                <a:tc rowSpan="2">
                  <a:txBody>
                    <a:bodyPr/>
                    <a:lstStyle/>
                    <a:p>
                      <a:pPr algn="ctr" fontAlgn="base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Actin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1646" marR="51646" marT="14177" marB="14177" anchor="ctr"/>
                </a:tc>
                <a:tc>
                  <a:txBody>
                    <a:bodyPr/>
                    <a:lstStyle/>
                    <a:p>
                      <a:pPr algn="ctr" fontAlgn="base" latinLnBrk="0">
                        <a:lnSpc>
                          <a:spcPct val="120000"/>
                        </a:lnSpc>
                        <a:spcAft>
                          <a:spcPts val="4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1646" marR="51646" marT="14177" marB="14177" anchor="ctr"/>
                </a:tc>
                <a:tc>
                  <a:txBody>
                    <a:bodyPr/>
                    <a:lstStyle/>
                    <a:p>
                      <a:pPr algn="l" fontAlgn="base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ko-KR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‘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GGCAAACAGAGAGAAAATGACTCAAATC-3</a:t>
                      </a:r>
                      <a:r>
                        <a:rPr lang="ko-KR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1646" marR="51646" marT="14177" marB="14177" anchor="ctr"/>
                </a:tc>
                <a:extLst>
                  <a:ext uri="{0D108BD9-81ED-4DB2-BD59-A6C34878D82A}">
                    <a16:rowId xmlns:a16="http://schemas.microsoft.com/office/drawing/2014/main" val="1327939788"/>
                  </a:ext>
                </a:extLst>
              </a:tr>
              <a:tr h="26692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0">
                        <a:lnSpc>
                          <a:spcPct val="120000"/>
                        </a:lnSpc>
                        <a:spcAft>
                          <a:spcPts val="4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1646" marR="51646" marT="14177" marB="14177" anchor="ctr"/>
                </a:tc>
                <a:tc>
                  <a:txBody>
                    <a:bodyPr/>
                    <a:lstStyle/>
                    <a:p>
                      <a:pPr algn="just" fontAlgn="base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ko-KR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‘</a:t>
                      </a: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CCTCTTTCGGTCAGAATTTTCATGAGAT-3</a:t>
                      </a:r>
                      <a:r>
                        <a:rPr lang="ko-KR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1646" marR="51646" marT="14177" marB="14177" anchor="ctr"/>
                </a:tc>
                <a:extLst>
                  <a:ext uri="{0D108BD9-81ED-4DB2-BD59-A6C34878D82A}">
                    <a16:rowId xmlns:a16="http://schemas.microsoft.com/office/drawing/2014/main" val="3028644774"/>
                  </a:ext>
                </a:extLst>
              </a:tr>
              <a:tr h="266926">
                <a:tc rowSpan="2">
                  <a:txBody>
                    <a:bodyPr/>
                    <a:lstStyle/>
                    <a:p>
                      <a:pPr algn="ctr" fontAlgn="base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Hd3a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1646" marR="51646" marT="14177" marB="14177" anchor="ctr"/>
                </a:tc>
                <a:tc>
                  <a:txBody>
                    <a:bodyPr/>
                    <a:lstStyle/>
                    <a:p>
                      <a:pPr algn="ctr" fontAlgn="base" latinLnBrk="0">
                        <a:lnSpc>
                          <a:spcPct val="107000"/>
                        </a:lnSpc>
                        <a:spcAft>
                          <a:spcPts val="400"/>
                        </a:spcAft>
                      </a:pPr>
                      <a:r>
                        <a:rPr lang="en-US" sz="1000" kern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1646" marR="51646" marT="14177" marB="14177" anchor="ctr"/>
                </a:tc>
                <a:tc>
                  <a:txBody>
                    <a:bodyPr/>
                    <a:lstStyle/>
                    <a:p>
                      <a:pPr algn="just" fontAlgn="base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ko-KR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‘</a:t>
                      </a:r>
                      <a:r>
                        <a:rPr lang="en-US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GCAACCTTTGGACAGGAGATAGTGT-3</a:t>
                      </a:r>
                      <a:r>
                        <a:rPr lang="ko-KR" sz="10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1646" marR="51646" marT="14177" marB="14177" anchor="ctr"/>
                </a:tc>
                <a:extLst>
                  <a:ext uri="{0D108BD9-81ED-4DB2-BD59-A6C34878D82A}">
                    <a16:rowId xmlns:a16="http://schemas.microsoft.com/office/drawing/2014/main" val="1422162828"/>
                  </a:ext>
                </a:extLst>
              </a:tr>
              <a:tr h="26692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ase" latinLnBrk="0">
                        <a:lnSpc>
                          <a:spcPct val="107000"/>
                        </a:lnSpc>
                        <a:spcAft>
                          <a:spcPts val="400"/>
                        </a:spcAft>
                      </a:pPr>
                      <a:r>
                        <a:rPr lang="en-US" sz="10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1646" marR="51646" marT="14177" marB="14177" anchor="ctr"/>
                </a:tc>
                <a:tc>
                  <a:txBody>
                    <a:bodyPr/>
                    <a:lstStyle/>
                    <a:p>
                      <a:pPr algn="just" fontAlgn="base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r>
                        <a:rPr lang="ko-KR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‘</a:t>
                      </a:r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CCACTCTCTCTCTGGCAGTTATAATA-3</a:t>
                      </a:r>
                      <a:r>
                        <a:rPr lang="ko-KR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51646" marR="51646" marT="14177" marB="14177" anchor="ctr"/>
                </a:tc>
                <a:extLst>
                  <a:ext uri="{0D108BD9-81ED-4DB2-BD59-A6C34878D82A}">
                    <a16:rowId xmlns:a16="http://schemas.microsoft.com/office/drawing/2014/main" val="4074654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27078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11</TotalTime>
  <Words>51</Words>
  <Application>Microsoft Office PowerPoint</Application>
  <PresentationFormat>와이드스크린</PresentationFormat>
  <Paragraphs>14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허재복</dc:creator>
  <cp:lastModifiedBy>허재복</cp:lastModifiedBy>
  <cp:revision>155</cp:revision>
  <cp:lastPrinted>2021-07-28T04:06:38Z</cp:lastPrinted>
  <dcterms:created xsi:type="dcterms:W3CDTF">2021-07-16T04:20:22Z</dcterms:created>
  <dcterms:modified xsi:type="dcterms:W3CDTF">2022-10-18T06:36:59Z</dcterms:modified>
</cp:coreProperties>
</file>